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1.png" ContentType="image/png"/>
  <Override PartName="/ppt/media/image2.png" ContentType="image/pn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FEF200-4549-4C89-9BE0-BEAD69892F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539640" y="427032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0818E4-04E3-41A8-9663-21BFA4DC96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53964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452232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11FCB8-9579-4B84-8AC0-1AA491DAC5D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37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3"/>
          <p:cNvSpPr>
            <a:spLocks noGrp="1"/>
          </p:cNvSpPr>
          <p:nvPr>
            <p:ph/>
          </p:nvPr>
        </p:nvSpPr>
        <p:spPr>
          <a:xfrm>
            <a:off x="3167640" y="21207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4"/>
          <p:cNvSpPr>
            <a:spLocks noGrp="1"/>
          </p:cNvSpPr>
          <p:nvPr>
            <p:ph/>
          </p:nvPr>
        </p:nvSpPr>
        <p:spPr>
          <a:xfrm>
            <a:off x="5795280" y="21207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5"/>
          <p:cNvSpPr>
            <a:spLocks noGrp="1"/>
          </p:cNvSpPr>
          <p:nvPr>
            <p:ph/>
          </p:nvPr>
        </p:nvSpPr>
        <p:spPr>
          <a:xfrm>
            <a:off x="539640" y="427032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6"/>
          <p:cNvSpPr>
            <a:spLocks noGrp="1"/>
          </p:cNvSpPr>
          <p:nvPr>
            <p:ph/>
          </p:nvPr>
        </p:nvSpPr>
        <p:spPr>
          <a:xfrm>
            <a:off x="3167640" y="427032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7"/>
          <p:cNvSpPr>
            <a:spLocks noGrp="1"/>
          </p:cNvSpPr>
          <p:nvPr>
            <p:ph/>
          </p:nvPr>
        </p:nvSpPr>
        <p:spPr>
          <a:xfrm>
            <a:off x="5795280" y="427032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4FEB47-40B3-411A-AED7-1CBBBEF7404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539640" y="212076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539640" y="10537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53964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subTitle"/>
          </p:nvPr>
        </p:nvSpPr>
        <p:spPr>
          <a:xfrm>
            <a:off x="539640" y="212076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7ACC40-FF3A-4B7C-B182-181CD7A3D2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52232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539640" y="427032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539640" y="427032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53964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52232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167640" y="21207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5795280" y="21207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539640" y="427032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167640" y="427032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5795280" y="427032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CF2F8-4330-45F6-B044-B3D3280D09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FE8DCB-242D-4871-90C5-D9ADD88C79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E36B7-EC8F-4D34-89F0-9A7B866B9D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subTitle"/>
          </p:nvPr>
        </p:nvSpPr>
        <p:spPr>
          <a:xfrm>
            <a:off x="539640" y="10537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696756-EB5D-419A-9E3B-D4D562A160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53964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CA9DCF-F9EE-482D-B813-B85446011B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452232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14B4AA-C1D3-47CB-B8B5-443888EF91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/>
          </p:nvPr>
        </p:nvSpPr>
        <p:spPr>
          <a:xfrm>
            <a:off x="539640" y="427032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FC8CCF-8DCE-463B-90D2-03173DF9C4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0" name="Picture 10" descr=""/>
          <p:cNvPicPr/>
          <p:nvPr/>
        </p:nvPicPr>
        <p:blipFill>
          <a:blip r:embed="rId2"/>
          <a:stretch/>
        </p:blipFill>
        <p:spPr>
          <a:xfrm>
            <a:off x="7178760" y="182520"/>
            <a:ext cx="1727280" cy="704880"/>
          </a:xfrm>
          <a:prstGeom prst="rect">
            <a:avLst/>
          </a:prstGeom>
          <a:ln w="0">
            <a:noFill/>
          </a:ln>
        </p:spPr>
      </p:pic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870052"/>
                </a:solidFill>
                <a:latin typeface="Arial"/>
              </a:rPr>
              <a:t>Click to edit the title text format</a:t>
            </a: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body"/>
          </p:nvPr>
        </p:nvSpPr>
        <p:spPr>
          <a:xfrm>
            <a:off x="539640" y="212076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870052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000000"/>
              </a:buClr>
              <a:buFont typeface="Wingdings" charset="2"/>
              <a:buChar char="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870052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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499"/>
              </a:spcBef>
              <a:buClr>
                <a:srgbClr val="870052"/>
              </a:buClr>
              <a:buFont typeface="Wingdings" charset="2"/>
              <a:buChar char="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dt" idx="1"/>
          </p:nvPr>
        </p:nvSpPr>
        <p:spPr>
          <a:xfrm>
            <a:off x="6553080" y="6476760"/>
            <a:ext cx="1905120" cy="22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800" spc="-1" strike="noStrike">
                <a:solidFill>
                  <a:srgbClr val="80808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F76D62-A30B-4E31-8F19-DB33ABFCC928}" type="datetime3">
              <a:rPr b="0" lang="sv-SE" sz="800" spc="-1" strike="noStrike">
                <a:solidFill>
                  <a:srgbClr val="808080"/>
                </a:solidFill>
                <a:latin typeface="Arial"/>
              </a:rPr>
              <a:t>29 augusti 2026</a:t>
            </a:fld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ftr" idx="2"/>
          </p:nvPr>
        </p:nvSpPr>
        <p:spPr>
          <a:xfrm>
            <a:off x="456840" y="6476760"/>
            <a:ext cx="2895480" cy="22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800" spc="-1" strike="noStrike">
                <a:solidFill>
                  <a:srgbClr val="80808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800" spc="-1" strike="noStrike">
                <a:solidFill>
                  <a:srgbClr val="808080"/>
                </a:solidFill>
                <a:latin typeface="Arial"/>
              </a:rPr>
              <a:t>Ulf Gehrmann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5"/>
          <p:cNvSpPr>
            <a:spLocks noGrp="1"/>
          </p:cNvSpPr>
          <p:nvPr>
            <p:ph type="sldNum" idx="3"/>
          </p:nvPr>
        </p:nvSpPr>
        <p:spPr>
          <a:xfrm>
            <a:off x="8229240" y="6476760"/>
            <a:ext cx="685800" cy="22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sv-SE" sz="800" spc="-1" strike="noStrike">
                <a:solidFill>
                  <a:srgbClr val="80808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697E55-72B3-4579-907D-3544B81E5412}" type="slidenum">
              <a:rPr b="1" lang="sv-SE" sz="800" spc="-1" strike="noStrike">
                <a:solidFill>
                  <a:srgbClr val="808080"/>
                </a:solidFill>
                <a:latin typeface="Arial"/>
              </a:rPr>
              <a:t>&lt;number&gt;</a:t>
            </a:fld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Line 7"/>
          <p:cNvSpPr/>
          <p:nvPr/>
        </p:nvSpPr>
        <p:spPr>
          <a:xfrm>
            <a:off x="533520" y="6400800"/>
            <a:ext cx="8305560" cy="0"/>
          </a:xfrm>
          <a:prstGeom prst="line">
            <a:avLst/>
          </a:prstGeom>
          <a:ln w="9360">
            <a:solidFill>
              <a:srgbClr val="87005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14" descr=""/>
          <p:cNvPicPr/>
          <p:nvPr/>
        </p:nvPicPr>
        <p:blipFill>
          <a:blip r:embed="rId2"/>
          <a:srcRect l="1666" t="2221" r="1681" b="2247"/>
          <a:stretch/>
        </p:blipFill>
        <p:spPr>
          <a:xfrm>
            <a:off x="152280" y="152280"/>
            <a:ext cx="8839440" cy="6553440"/>
          </a:xfrm>
          <a:prstGeom prst="rect">
            <a:avLst/>
          </a:prstGeom>
          <a:ln w="0">
            <a:noFill/>
          </a:ln>
        </p:spPr>
      </p:pic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870052"/>
                </a:solidFill>
                <a:latin typeface="Arial"/>
              </a:rPr>
              <a:t>Click to edit the title text format</a:t>
            </a: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539640" y="212076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870052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000000"/>
              </a:buClr>
              <a:buFont typeface="Wingdings" charset="2"/>
              <a:buChar char="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870052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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499"/>
              </a:spcBef>
              <a:buClr>
                <a:srgbClr val="870052"/>
              </a:buClr>
              <a:buFont typeface="Wingdings" charset="2"/>
              <a:buChar char="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ext Box 2"/>
          <p:cNvSpPr/>
          <p:nvPr/>
        </p:nvSpPr>
        <p:spPr>
          <a:xfrm>
            <a:off x="0" y="328680"/>
            <a:ext cx="2016000" cy="29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400" spc="-1" strike="noStrike">
                <a:solidFill>
                  <a:srgbClr val="000000"/>
                </a:solidFill>
                <a:latin typeface="Arial"/>
                <a:ea typeface="ＭＳ 明朝"/>
              </a:rPr>
              <a:t>Table S2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3" name=""/>
          <p:cNvGraphicFramePr/>
          <p:nvPr/>
        </p:nvGraphicFramePr>
        <p:xfrm>
          <a:off x="179280" y="981000"/>
          <a:ext cx="7631280" cy="3791160"/>
        </p:xfrm>
        <a:graphic>
          <a:graphicData uri="http://schemas.openxmlformats.org/drawingml/2006/table">
            <a:tbl>
              <a:tblPr/>
              <a:tblGrid>
                <a:gridCol w="966960"/>
                <a:gridCol w="771480"/>
                <a:gridCol w="820800"/>
                <a:gridCol w="757080"/>
                <a:gridCol w="714600"/>
                <a:gridCol w="763560"/>
                <a:gridCol w="590400"/>
                <a:gridCol w="843120"/>
                <a:gridCol w="842760"/>
                <a:gridCol w="560520"/>
              </a:tblGrid>
              <a:tr h="4111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sponding cells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imulus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ncentrations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ell number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C</a:t>
                      </a:r>
                      <a:r>
                        <a:rPr b="1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§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edian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(range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E </a:t>
                      </a:r>
                      <a:r>
                        <a:rPr b="0" lang="en-GB" sz="7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†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edian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(range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-value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(Mann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-Whitney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C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edian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(range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E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edian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(range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-value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(Mann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Whitney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7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 x 10</a:t>
                      </a:r>
                      <a:r>
                        <a:rPr b="1" lang="sv-SE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dPBMC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dium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( 0 – 4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 (0 – 6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40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5 (50 – 71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 (49 – 86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35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91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HC: n=7, AE: n=7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alaEx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 ng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 (0 – 5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 (2 – 80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11 *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8 (74 – 525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2 (68 – 428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55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76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ig. 2A, B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alaEx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0 ng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 (1 - 22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6 (3 - 211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14 *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79 (161 - 1169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84 (110 - 1191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694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94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ala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 x 10</a:t>
                      </a:r>
                      <a:r>
                        <a:rPr b="1" lang="sv-SE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cells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6 (7 - 40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7 (26 - 333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03 *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01 (100 - 286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23 (64 - 591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65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4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 x 10</a:t>
                      </a:r>
                      <a:r>
                        <a:rPr b="1" lang="sv-SE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dPBMC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dium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(0 – 3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(0 – 28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43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06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HC: n=6, AE: n=7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Cexo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 µg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 (1 - 11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 (1 - 54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628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96 (19 - 460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7  (12 - 160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32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91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ig. 4A, B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Cexo Mala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 µg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 (2 - 19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8 (1 - 322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316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69 (81 - 341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62 (52 - 435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445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76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CMala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 x 10</a:t>
                      </a:r>
                      <a:r>
                        <a:rPr b="1" lang="sv-SE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MDDC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4 (31 – 174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9 (69 – 500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5 </a:t>
                      </a: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*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9 (9 – 571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6 (98 – 884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45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91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ala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 x 10</a:t>
                      </a:r>
                      <a:r>
                        <a:rPr b="1" lang="sv-SE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cells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6 (7 - 40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5 (28 - 504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14 *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0 (6 - 700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36 (33 - 604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366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7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x 10</a:t>
                      </a:r>
                      <a:r>
                        <a:rPr b="1" lang="sv-SE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PBMC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dium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(0 – 2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 (0 – 5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5 </a:t>
                      </a: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*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1 (62 – 113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 (54 – 172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45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76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HC: n=8, AE: n=8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lexos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 µg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 (0 - 5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 (0 - 14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124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66 (70 – 1431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2 (122 - 1410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59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91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ig. 5C, D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ala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x 10</a:t>
                      </a:r>
                      <a:r>
                        <a:rPr b="1" lang="sv-SE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cells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 (0 - 1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6 (1 - 88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04 *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34 (100 - 250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64 (69 - 960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344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94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lexos + Mala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 µg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x 10</a:t>
                      </a:r>
                      <a:r>
                        <a:rPr b="1" lang="sv-SE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cells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 (0 - 4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8 (1 - 96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02 *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88 (79 - 1116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18 (143 - 2029)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7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645</a:t>
                      </a:r>
                      <a:endParaRPr b="1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8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21T16:16:51Z</dcterms:created>
  <dc:creator>QARH</dc:creator>
  <dc:description/>
  <dc:language>en-US</dc:language>
  <cp:lastModifiedBy>Ulf Gehrmann</cp:lastModifiedBy>
  <cp:lastPrinted>2005-09-23T14:22:03Z</cp:lastPrinted>
  <dcterms:modified xsi:type="dcterms:W3CDTF">2011-06-21T09:01:08Z</dcterms:modified>
  <cp:revision>260</cp:revision>
  <dc:subject/>
  <dc:title>The role of exosomes in immune regulation and allergy</dc:title>
</cp:coreProperties>
</file>